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0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4" autoAdjust="0"/>
    <p:restoredTop sz="94660"/>
  </p:normalViewPr>
  <p:slideViewPr>
    <p:cSldViewPr snapToGrid="0">
      <p:cViewPr varScale="1">
        <p:scale>
          <a:sx n="88" d="100"/>
          <a:sy n="88" d="100"/>
        </p:scale>
        <p:origin x="28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3488434"/>
              </p:ext>
            </p:extLst>
          </p:nvPr>
        </p:nvGraphicFramePr>
        <p:xfrm>
          <a:off x="859444" y="1575564"/>
          <a:ext cx="2147653" cy="3387475"/>
        </p:xfrm>
        <a:graphic>
          <a:graphicData uri="http://schemas.openxmlformats.org/drawingml/2006/table">
            <a:tbl>
              <a:tblPr/>
              <a:tblGrid>
                <a:gridCol w="115570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9195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</a:tblGrid>
              <a:tr h="391078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file 4</a:t>
                      </a:r>
                    </a:p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sertion Sites</a:t>
                      </a:r>
                      <a:endParaRPr lang="en-US" sz="1200" b="1" i="0" u="none" strike="noStrike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NA/</a:t>
                      </a:r>
                    </a:p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37]</a:t>
                      </a:r>
                      <a:endParaRPr lang="en-US" sz="1200" b="1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296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KS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2960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K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2960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2960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M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2960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WC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2960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H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296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S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2960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2960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L08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2960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I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296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O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296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41089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R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54025" y="863982"/>
            <a:ext cx="36329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4 Table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RNA level of the endogenous genes at profil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sertion site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344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51</Words>
  <Application>Microsoft Office PowerPoint</Application>
  <PresentationFormat>Letter Paper (8.5x11 in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Manyu Du</cp:lastModifiedBy>
  <cp:revision>284</cp:revision>
  <cp:lastPrinted>2016-12-22T22:05:19Z</cp:lastPrinted>
  <dcterms:created xsi:type="dcterms:W3CDTF">2016-06-14T18:48:14Z</dcterms:created>
  <dcterms:modified xsi:type="dcterms:W3CDTF">2017-04-08T21:18:02Z</dcterms:modified>
</cp:coreProperties>
</file>